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749C3-F283-4F6C-9E10-82D6517B97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9C8CC-E914-4BFA-9152-46D6B66165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D5EA1-CD35-4923-8BD1-ACC994962A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27046-BEB6-4358-9466-65F1B000B1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E1C9F-D6F8-4FAB-A6FC-189DB4B006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A35E2-F467-4D26-BFE3-FCCCAD55E5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3295A-3284-4F15-9E15-C98CAF9259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090DB-3BF1-47EA-9E7A-FB964683EF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68E1A-851B-474B-994D-775F385A62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B3232-C338-4379-BDA3-7F8D41C4E4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1F753-C1D1-4DA0-91D8-FCD011003C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5C8C3-1CEB-4A06-805B-51C8CDF994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D42228-73CA-4CA2-BC2B-786195A0BE0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4901" t="19742" r="11190" b="14171"/>
          <a:stretch/>
        </p:blipFill>
        <p:spPr>
          <a:xfrm>
            <a:off x="1238400" y="1022400"/>
            <a:ext cx="1511280" cy="17017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6174" t="30844" r="1887" b="0"/>
          <a:stretch/>
        </p:blipFill>
        <p:spPr>
          <a:xfrm>
            <a:off x="2830680" y="1022400"/>
            <a:ext cx="1303200" cy="17114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14192" t="37659" r="15751" b="46381"/>
          <a:stretch/>
        </p:blipFill>
        <p:spPr>
          <a:xfrm>
            <a:off x="1222200" y="2759040"/>
            <a:ext cx="1521000" cy="1936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39600" t="43061" r="0" b="41261"/>
          <a:stretch/>
        </p:blipFill>
        <p:spPr>
          <a:xfrm>
            <a:off x="2827440" y="2765520"/>
            <a:ext cx="1312920" cy="1760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4133880" y="1893960"/>
            <a:ext cx="136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198680" y="17701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133880" y="1392120"/>
            <a:ext cx="136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192200" y="12654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1078200" y="65484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1298880" y="61812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urk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1581480" y="64692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93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1869480" y="6969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2021760" y="59544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059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2313360" y="658800"/>
            <a:ext cx="5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2402280" y="375480"/>
            <a:ext cx="110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A-MB-4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133880" y="2535120"/>
            <a:ext cx="136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92200" y="24084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042800">
            <a:off x="2937240" y="66816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e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3148920" y="621720"/>
            <a:ext cx="60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T-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3402000" y="61740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aco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830040" y="774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"/>
          <p:cNvGrpSpPr/>
          <p:nvPr/>
        </p:nvGrpSpPr>
        <p:grpSpPr>
          <a:xfrm>
            <a:off x="999720" y="2476440"/>
            <a:ext cx="228600" cy="85680"/>
            <a:chOff x="999720" y="2476440"/>
            <a:chExt cx="228600" cy="85680"/>
          </a:xfrm>
        </p:grpSpPr>
        <p:sp>
          <p:nvSpPr>
            <p:cNvPr id="63" name=""/>
            <p:cNvSpPr/>
            <p:nvPr/>
          </p:nvSpPr>
          <p:spPr>
            <a:xfrm flipH="1">
              <a:off x="999720" y="2562120"/>
              <a:ext cx="152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1152000" y="2476440"/>
              <a:ext cx="0" cy="85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152000" y="2476440"/>
              <a:ext cx="76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"/>
          <p:cNvGrpSpPr/>
          <p:nvPr/>
        </p:nvGrpSpPr>
        <p:grpSpPr>
          <a:xfrm>
            <a:off x="987840" y="990720"/>
            <a:ext cx="239400" cy="300600"/>
            <a:chOff x="987840" y="990720"/>
            <a:chExt cx="239400" cy="300600"/>
          </a:xfrm>
        </p:grpSpPr>
        <p:sp>
          <p:nvSpPr>
            <p:cNvPr id="67" name=""/>
            <p:cNvSpPr/>
            <p:nvPr/>
          </p:nvSpPr>
          <p:spPr>
            <a:xfrm flipH="1">
              <a:off x="987840" y="990720"/>
              <a:ext cx="152280" cy="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140120" y="991080"/>
              <a:ext cx="10800" cy="300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1150920" y="1288080"/>
              <a:ext cx="76320" cy="2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 flipH="1">
            <a:off x="999720" y="1371600"/>
            <a:ext cx="22860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987480" y="1814040"/>
            <a:ext cx="237240" cy="254880"/>
            <a:chOff x="987480" y="1814040"/>
            <a:chExt cx="237240" cy="254880"/>
          </a:xfrm>
        </p:grpSpPr>
        <p:sp>
          <p:nvSpPr>
            <p:cNvPr id="72" name=""/>
            <p:cNvSpPr/>
            <p:nvPr/>
          </p:nvSpPr>
          <p:spPr>
            <a:xfrm flipH="1">
              <a:off x="987480" y="1814040"/>
              <a:ext cx="151920" cy="5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139400" y="1814400"/>
              <a:ext cx="9360" cy="254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148760" y="2065680"/>
              <a:ext cx="75960" cy="2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"/>
          <p:cNvSpPr/>
          <p:nvPr/>
        </p:nvSpPr>
        <p:spPr>
          <a:xfrm flipH="1">
            <a:off x="1009440" y="2197080"/>
            <a:ext cx="22860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0640" y="1704240"/>
            <a:ext cx="97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TNFRSF11A_</a:t>
            </a:r>
            <a:r>
              <a:rPr b="0" i="1" lang="el-GR" sz="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88360" y="1247040"/>
            <a:ext cx="76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TNFRSF11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-91440" y="885240"/>
            <a:ext cx="1195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TNFRSF11A_exon9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800" y="2086920"/>
            <a:ext cx="106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TNFRSF11A_</a:t>
            </a:r>
            <a:r>
              <a:rPr b="0" i="1" lang="el-GR" sz="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8,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-74520" y="2447280"/>
            <a:ext cx="114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TNFRSF11A_</a:t>
            </a:r>
            <a:r>
              <a:rPr b="0" i="1" lang="el-GR" sz="800" spc="-1" strike="noStrike">
                <a:solidFill>
                  <a:srgbClr val="000000"/>
                </a:solidFill>
                <a:latin typeface="Arial"/>
              </a:rPr>
              <a:t>Δ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7,8,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8920" y="106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088520" y="273528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380880" y="3746520"/>
          <a:ext cx="4343400" cy="1601640"/>
        </p:xfrm>
        <a:graphic>
          <a:graphicData uri="http://schemas.openxmlformats.org/drawingml/2006/table">
            <a:tbl>
              <a:tblPr/>
              <a:tblGrid>
                <a:gridCol w="1067040"/>
                <a:gridCol w="380880"/>
                <a:gridCol w="1523880"/>
                <a:gridCol w="1371600"/>
              </a:tblGrid>
              <a:tr h="3985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NFRSF11A_Δ7,8,9 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-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09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istological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ad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59±23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.99±14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3±8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5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8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85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</a:t>
                      </a:r>
                      <a:r>
                        <a:rPr b="1" lang="el-G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1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4" name=""/>
          <p:cNvGraphicFramePr/>
          <p:nvPr/>
        </p:nvGraphicFramePr>
        <p:xfrm>
          <a:off x="4876920" y="457200"/>
          <a:ext cx="4038480" cy="5721480"/>
        </p:xfrm>
        <a:graphic>
          <a:graphicData uri="http://schemas.openxmlformats.org/drawingml/2006/table">
            <a:tbl>
              <a:tblPr/>
              <a:tblGrid>
                <a:gridCol w="696960"/>
                <a:gridCol w="487080"/>
                <a:gridCol w="557280"/>
                <a:gridCol w="765360"/>
                <a:gridCol w="487080"/>
                <a:gridCol w="417600"/>
                <a:gridCol w="627120"/>
              </a:tblGrid>
              <a:tr h="5504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i-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Ηe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ad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5" name=""/>
          <p:cNvSpPr/>
          <p:nvPr/>
        </p:nvSpPr>
        <p:spPr>
          <a:xfrm>
            <a:off x="126720" y="3319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573440" y="182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87000" y="5364000"/>
            <a:ext cx="427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ariable correlated with grade 3 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†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ariable correlated with grad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4T15:31:39Z</dcterms:created>
  <dc:creator>tasos p</dc:creator>
  <dc:description/>
  <dc:language>en-US</dc:language>
  <cp:lastModifiedBy>tasos p</cp:lastModifiedBy>
  <dcterms:modified xsi:type="dcterms:W3CDTF">2012-05-07T13:37:12Z</dcterms:modified>
  <cp:revision>23</cp:revision>
  <dc:subject/>
  <dc:title>Διαφάνεια 1</dc:title>
</cp:coreProperties>
</file>